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64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213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367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2415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82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3517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6727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6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9166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9653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954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9B651-F58B-4CD3-8714-50D4107A92E8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60CCE-1E1E-429D-9002-1A3783A18D8E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769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1077" y="265043"/>
            <a:ext cx="8348870" cy="48768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362435" y="5141843"/>
            <a:ext cx="11502886" cy="12777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istribution of pairwise identity-by-state (IBS) distance among lentil accessions genotyped in this study. The red curve highlights the theoretical Gaussian distribution obtained with the mean and standard deviation (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d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pairwise IBS distances observed for individuals of the pure line cultivar ‘Laird’. Vertical red lines cut the curve for IBS = mean ± 3 sd. 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32227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DZ-Forum.n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3</cp:revision>
  <dcterms:created xsi:type="dcterms:W3CDTF">2019-04-29T13:18:08Z</dcterms:created>
  <dcterms:modified xsi:type="dcterms:W3CDTF">2019-04-29T13:26:27Z</dcterms:modified>
</cp:coreProperties>
</file>